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0" r:id="rId3"/>
    <p:sldId id="268" r:id="rId4"/>
    <p:sldId id="259" r:id="rId5"/>
    <p:sldId id="265" r:id="rId6"/>
    <p:sldId id="267" r:id="rId7"/>
    <p:sldId id="266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9" d="100"/>
          <a:sy n="89" d="100"/>
        </p:scale>
        <p:origin x="46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7658-ABE4-49D2-BEAD-730833CCBC7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4616B-A3C6-460E-868E-622F723B24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01663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7658-ABE4-49D2-BEAD-730833CCBC7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4616B-A3C6-460E-868E-622F723B24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44107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7658-ABE4-49D2-BEAD-730833CCBC7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4616B-A3C6-460E-868E-622F723B24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45202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7658-ABE4-49D2-BEAD-730833CCBC7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4616B-A3C6-460E-868E-622F723B24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79124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7658-ABE4-49D2-BEAD-730833CCBC7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4616B-A3C6-460E-868E-622F723B24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95581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7658-ABE4-49D2-BEAD-730833CCBC7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4616B-A3C6-460E-868E-622F723B24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46017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7658-ABE4-49D2-BEAD-730833CCBC7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4616B-A3C6-460E-868E-622F723B24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91324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7658-ABE4-49D2-BEAD-730833CCBC7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4616B-A3C6-460E-868E-622F723B24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36393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7658-ABE4-49D2-BEAD-730833CCBC7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4616B-A3C6-460E-868E-622F723B24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9011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7658-ABE4-49D2-BEAD-730833CCBC7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4616B-A3C6-460E-868E-622F723B24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5612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7658-ABE4-49D2-BEAD-730833CCBC7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4616B-A3C6-460E-868E-622F723B24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0568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E57658-ABE4-49D2-BEAD-730833CCBC7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74616B-A3C6-460E-868E-622F723B24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13614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2027207"/>
            <a:ext cx="9144000" cy="1482755"/>
          </a:xfrm>
        </p:spPr>
        <p:txBody>
          <a:bodyPr>
            <a:noAutofit/>
          </a:bodyPr>
          <a:lstStyle/>
          <a:p>
            <a:r>
              <a:rPr 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S2.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GSEA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of 247 genes linked by GREAT with 351 human-specific LTR7 and LTR5_Hs using the Enrichr bioinformatics platform (A – F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b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Related to </a:t>
            </a:r>
            <a:r>
              <a:rPr 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5.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Inference of putative phenotypic impacts of human-specific LTR7 &amp; LTR5_Hs loci based on GREAT algorithm-guided functional annotations of proximity placement-linked genes. </a:t>
            </a:r>
            <a:endParaRPr lang="en-US" sz="1800" dirty="0"/>
          </a:p>
        </p:txBody>
      </p:sp>
    </p:spTree>
    <p:extLst>
      <p:ext uri="{BB962C8B-B14F-4D97-AF65-F5344CB8AC3E}">
        <p14:creationId xmlns:p14="http://schemas.microsoft.com/office/powerpoint/2010/main" val="30141757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5212" y="523875"/>
            <a:ext cx="4981575" cy="581025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84377" y="198408"/>
            <a:ext cx="3189206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/>
              <a:t>351 </a:t>
            </a:r>
            <a:r>
              <a:rPr lang="en-US" sz="1400" b="1" dirty="0" err="1" smtClean="0"/>
              <a:t>hs</a:t>
            </a:r>
            <a:r>
              <a:rPr lang="en-US" sz="1400" b="1" dirty="0" smtClean="0"/>
              <a:t> LTR7 &amp; LTR5_Hs loci</a:t>
            </a:r>
          </a:p>
          <a:p>
            <a:pPr algn="ctr"/>
            <a:r>
              <a:rPr lang="en-US" sz="1400" b="1" dirty="0" smtClean="0"/>
              <a:t>247 genes: </a:t>
            </a:r>
          </a:p>
          <a:p>
            <a:pPr algn="ctr"/>
            <a:r>
              <a:rPr lang="en-US" sz="1400" b="1" dirty="0" err="1" smtClean="0"/>
              <a:t>lncHUB</a:t>
            </a:r>
            <a:r>
              <a:rPr lang="en-US" sz="1400" b="1" dirty="0" smtClean="0"/>
              <a:t> lncRNA co-expression database; </a:t>
            </a:r>
          </a:p>
          <a:p>
            <a:pPr algn="ctr"/>
            <a:r>
              <a:rPr lang="en-US" sz="1400" b="1" dirty="0" smtClean="0"/>
              <a:t>top 10 significantly enriched records</a:t>
            </a:r>
            <a:endParaRPr lang="en-US" sz="1400" b="1" dirty="0"/>
          </a:p>
        </p:txBody>
      </p:sp>
      <p:sp>
        <p:nvSpPr>
          <p:cNvPr id="5" name="TextBox 2"/>
          <p:cNvSpPr txBox="1"/>
          <p:nvPr/>
        </p:nvSpPr>
        <p:spPr>
          <a:xfrm>
            <a:off x="20129" y="8955"/>
            <a:ext cx="359434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3592664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950899" y="17896"/>
            <a:ext cx="398038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 smtClean="0"/>
              <a:t>351 human-specific LTR7 &amp; LTR5_Hs loci</a:t>
            </a:r>
          </a:p>
          <a:p>
            <a:pPr algn="ctr"/>
            <a:r>
              <a:rPr lang="en-US" b="1" dirty="0" smtClean="0"/>
              <a:t>247 genes</a:t>
            </a:r>
            <a:endParaRPr lang="en-US" b="1" dirty="0"/>
          </a:p>
        </p:txBody>
      </p:sp>
      <p:pic>
        <p:nvPicPr>
          <p:cNvPr id="2050" name="Picture 2" descr="https://appyters.maayanlab.cloud/Enrichment_Analysis_Visualizer/07eaa3afd4eb745a668d45a726445b695bd6182b/Enrichr_results_bar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02060" y="2233228"/>
            <a:ext cx="6012612" cy="38397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965111" y="1062807"/>
            <a:ext cx="4487128" cy="4986768"/>
          </a:xfrm>
          <a:prstGeom prst="rect">
            <a:avLst/>
          </a:prstGeom>
        </p:spPr>
      </p:pic>
      <p:sp>
        <p:nvSpPr>
          <p:cNvPr id="6" name="5-Point Star 5"/>
          <p:cNvSpPr/>
          <p:nvPr/>
        </p:nvSpPr>
        <p:spPr>
          <a:xfrm>
            <a:off x="4710022" y="1502398"/>
            <a:ext cx="232913" cy="207041"/>
          </a:xfrm>
          <a:prstGeom prst="star5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5-Point Star 7"/>
          <p:cNvSpPr/>
          <p:nvPr/>
        </p:nvSpPr>
        <p:spPr>
          <a:xfrm>
            <a:off x="3950899" y="1502401"/>
            <a:ext cx="232913" cy="207041"/>
          </a:xfrm>
          <a:prstGeom prst="star5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5-Point Star 8"/>
          <p:cNvSpPr/>
          <p:nvPr/>
        </p:nvSpPr>
        <p:spPr>
          <a:xfrm>
            <a:off x="3464944" y="1502400"/>
            <a:ext cx="232913" cy="207041"/>
          </a:xfrm>
          <a:prstGeom prst="star5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5-Point Star 9"/>
          <p:cNvSpPr/>
          <p:nvPr/>
        </p:nvSpPr>
        <p:spPr>
          <a:xfrm>
            <a:off x="4948686" y="1502399"/>
            <a:ext cx="232913" cy="207041"/>
          </a:xfrm>
          <a:prstGeom prst="star5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5-Point Star 10"/>
          <p:cNvSpPr/>
          <p:nvPr/>
        </p:nvSpPr>
        <p:spPr>
          <a:xfrm>
            <a:off x="794988" y="6054331"/>
            <a:ext cx="232913" cy="207041"/>
          </a:xfrm>
          <a:prstGeom prst="star5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7" name="TextBox 6"/>
          <p:cNvSpPr txBox="1"/>
          <p:nvPr/>
        </p:nvSpPr>
        <p:spPr>
          <a:xfrm>
            <a:off x="1353399" y="5989526"/>
            <a:ext cx="27311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etal Gonad Marker Genes</a:t>
            </a:r>
            <a:endParaRPr lang="en-US" b="1" dirty="0"/>
          </a:p>
        </p:txBody>
      </p:sp>
      <p:cxnSp>
        <p:nvCxnSpPr>
          <p:cNvPr id="13" name="Straight Connector 12"/>
          <p:cNvCxnSpPr/>
          <p:nvPr/>
        </p:nvCxnSpPr>
        <p:spPr>
          <a:xfrm>
            <a:off x="3296495" y="2357839"/>
            <a:ext cx="1153837" cy="0"/>
          </a:xfrm>
          <a:prstGeom prst="line">
            <a:avLst/>
          </a:prstGeom>
          <a:ln w="508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 flipV="1">
            <a:off x="4710022" y="2357839"/>
            <a:ext cx="911885" cy="8792"/>
          </a:xfrm>
          <a:prstGeom prst="line">
            <a:avLst/>
          </a:prstGeom>
          <a:ln w="508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719068" y="6528123"/>
            <a:ext cx="455943" cy="1466"/>
          </a:xfrm>
          <a:prstGeom prst="line">
            <a:avLst/>
          </a:prstGeom>
          <a:ln w="508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1353399" y="6348341"/>
            <a:ext cx="38861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Naïve Primed Pluripotent States Genes</a:t>
            </a:r>
            <a:endParaRPr lang="en-US" b="1" dirty="0"/>
          </a:p>
        </p:txBody>
      </p:sp>
      <p:sp>
        <p:nvSpPr>
          <p:cNvPr id="15" name="TextBox 2"/>
          <p:cNvSpPr txBox="1"/>
          <p:nvPr/>
        </p:nvSpPr>
        <p:spPr>
          <a:xfrm>
            <a:off x="20129" y="8955"/>
            <a:ext cx="359434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4584924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5212" y="523875"/>
            <a:ext cx="4981575" cy="581025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84377" y="198408"/>
            <a:ext cx="3189206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/>
              <a:t>351 </a:t>
            </a:r>
            <a:r>
              <a:rPr lang="en-US" sz="1400" b="1" dirty="0" err="1" smtClean="0"/>
              <a:t>hs</a:t>
            </a:r>
            <a:r>
              <a:rPr lang="en-US" sz="1400" b="1" dirty="0" smtClean="0"/>
              <a:t> LTR7 &amp; LTR5_Hs loci</a:t>
            </a:r>
          </a:p>
          <a:p>
            <a:pPr algn="ctr"/>
            <a:r>
              <a:rPr lang="en-US" sz="1400" b="1" dirty="0" smtClean="0"/>
              <a:t>247 genes: </a:t>
            </a:r>
          </a:p>
          <a:p>
            <a:pPr algn="ctr"/>
            <a:r>
              <a:rPr lang="en-US" sz="1400" b="1" dirty="0" err="1" smtClean="0"/>
              <a:t>lncHUB</a:t>
            </a:r>
            <a:r>
              <a:rPr lang="en-US" sz="1400" b="1" dirty="0" smtClean="0"/>
              <a:t> lncRNA co-expression database; </a:t>
            </a:r>
          </a:p>
          <a:p>
            <a:pPr algn="ctr"/>
            <a:r>
              <a:rPr lang="en-US" sz="1400" b="1" dirty="0" smtClean="0"/>
              <a:t>top 30 significantly enriched records</a:t>
            </a:r>
            <a:endParaRPr lang="en-US" sz="1400" b="1" dirty="0"/>
          </a:p>
        </p:txBody>
      </p:sp>
      <p:sp>
        <p:nvSpPr>
          <p:cNvPr id="4" name="TextBox 2"/>
          <p:cNvSpPr txBox="1"/>
          <p:nvPr/>
        </p:nvSpPr>
        <p:spPr>
          <a:xfrm>
            <a:off x="20129" y="8955"/>
            <a:ext cx="359434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25503549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45227" y="765415"/>
            <a:ext cx="4981575" cy="5810250"/>
          </a:xfrm>
          <a:prstGeom prst="rect">
            <a:avLst/>
          </a:prstGeom>
        </p:spPr>
      </p:pic>
      <p:pic>
        <p:nvPicPr>
          <p:cNvPr id="3" name="Picture 2" descr="https://appyters.maayanlab.cloud/Enrichment_Analysis_Visualizer/07eaa3afd4eb745a668d45a726445b695bd6182b/Enrichr_results_ba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0936" y="1213160"/>
            <a:ext cx="6374291" cy="38397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3950899" y="17896"/>
            <a:ext cx="398038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 smtClean="0"/>
              <a:t>351 human-specific LTR7 &amp; LTR5_Hs loci</a:t>
            </a:r>
          </a:p>
          <a:p>
            <a:pPr algn="ctr"/>
            <a:r>
              <a:rPr lang="en-US" b="1" dirty="0" smtClean="0"/>
              <a:t>247 genes</a:t>
            </a:r>
            <a:endParaRPr lang="en-US" b="1" dirty="0"/>
          </a:p>
        </p:txBody>
      </p:sp>
      <p:sp>
        <p:nvSpPr>
          <p:cNvPr id="5" name="5-Point Star 4"/>
          <p:cNvSpPr/>
          <p:nvPr/>
        </p:nvSpPr>
        <p:spPr>
          <a:xfrm>
            <a:off x="794988" y="6054331"/>
            <a:ext cx="232913" cy="207041"/>
          </a:xfrm>
          <a:prstGeom prst="star5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/>
          </a:p>
        </p:txBody>
      </p:sp>
      <p:sp>
        <p:nvSpPr>
          <p:cNvPr id="6" name="TextBox 5"/>
          <p:cNvSpPr txBox="1"/>
          <p:nvPr/>
        </p:nvSpPr>
        <p:spPr>
          <a:xfrm>
            <a:off x="1353399" y="5989526"/>
            <a:ext cx="27311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etal Gonad Marker Genes</a:t>
            </a:r>
            <a:endParaRPr lang="en-US" b="1" dirty="0"/>
          </a:p>
        </p:txBody>
      </p:sp>
      <p:cxnSp>
        <p:nvCxnSpPr>
          <p:cNvPr id="7" name="Straight Connector 6"/>
          <p:cNvCxnSpPr/>
          <p:nvPr/>
        </p:nvCxnSpPr>
        <p:spPr>
          <a:xfrm>
            <a:off x="719068" y="6528123"/>
            <a:ext cx="455943" cy="1466"/>
          </a:xfrm>
          <a:prstGeom prst="line">
            <a:avLst/>
          </a:prstGeom>
          <a:ln w="508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1353399" y="6348341"/>
            <a:ext cx="38861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Naïve Primed Pluripotent States Genes</a:t>
            </a:r>
            <a:endParaRPr lang="en-US" b="1" dirty="0"/>
          </a:p>
        </p:txBody>
      </p:sp>
      <p:cxnSp>
        <p:nvCxnSpPr>
          <p:cNvPr id="9" name="Straight Connector 8"/>
          <p:cNvCxnSpPr/>
          <p:nvPr/>
        </p:nvCxnSpPr>
        <p:spPr>
          <a:xfrm flipV="1">
            <a:off x="8017549" y="3220481"/>
            <a:ext cx="0" cy="1049594"/>
          </a:xfrm>
          <a:prstGeom prst="line">
            <a:avLst/>
          </a:prstGeom>
          <a:ln w="508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 flipH="1" flipV="1">
            <a:off x="8017549" y="2107673"/>
            <a:ext cx="5017" cy="851187"/>
          </a:xfrm>
          <a:prstGeom prst="line">
            <a:avLst/>
          </a:prstGeom>
          <a:ln w="508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5-Point Star 13"/>
          <p:cNvSpPr/>
          <p:nvPr/>
        </p:nvSpPr>
        <p:spPr>
          <a:xfrm>
            <a:off x="6893755" y="2751819"/>
            <a:ext cx="232913" cy="207041"/>
          </a:xfrm>
          <a:prstGeom prst="star5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5-Point Star 14"/>
          <p:cNvSpPr/>
          <p:nvPr/>
        </p:nvSpPr>
        <p:spPr>
          <a:xfrm>
            <a:off x="6906696" y="3391586"/>
            <a:ext cx="232913" cy="207041"/>
          </a:xfrm>
          <a:prstGeom prst="star5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5-Point Star 15"/>
          <p:cNvSpPr/>
          <p:nvPr/>
        </p:nvSpPr>
        <p:spPr>
          <a:xfrm>
            <a:off x="6911086" y="3840158"/>
            <a:ext cx="232913" cy="207041"/>
          </a:xfrm>
          <a:prstGeom prst="star5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5-Point Star 16"/>
          <p:cNvSpPr/>
          <p:nvPr/>
        </p:nvSpPr>
        <p:spPr>
          <a:xfrm>
            <a:off x="6893754" y="2510288"/>
            <a:ext cx="232913" cy="207041"/>
          </a:xfrm>
          <a:prstGeom prst="star5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Box 2"/>
          <p:cNvSpPr txBox="1"/>
          <p:nvPr/>
        </p:nvSpPr>
        <p:spPr>
          <a:xfrm>
            <a:off x="20129" y="8955"/>
            <a:ext cx="359434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33587054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/>
          </p:nvPr>
        </p:nvGraphicFramePr>
        <p:xfrm>
          <a:off x="362313" y="1254125"/>
          <a:ext cx="11412744" cy="43486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86925"/>
                <a:gridCol w="815199"/>
                <a:gridCol w="951062"/>
                <a:gridCol w="951062"/>
                <a:gridCol w="951062"/>
                <a:gridCol w="951062"/>
                <a:gridCol w="1099866"/>
                <a:gridCol w="802257"/>
                <a:gridCol w="951063"/>
                <a:gridCol w="951062"/>
                <a:gridCol w="832448"/>
                <a:gridCol w="1069676"/>
              </a:tblGrid>
              <a:tr h="531543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Gonadal Mitotic Phase Fetal Germ </a:t>
                      </a:r>
                      <a:r>
                        <a:rPr lang="en-US" sz="1200" b="1" u="none" strike="noStrike" dirty="0" smtClean="0">
                          <a:effectLst/>
                        </a:rPr>
                        <a:t>cells: </a:t>
                      </a:r>
                    </a:p>
                    <a:p>
                      <a:pPr algn="l" fontAlgn="b"/>
                      <a:r>
                        <a:rPr lang="en-US" sz="1200" b="1" u="none" strike="noStrike" dirty="0" smtClean="0">
                          <a:effectLst/>
                        </a:rPr>
                        <a:t>Fetal </a:t>
                      </a:r>
                      <a:r>
                        <a:rPr lang="en-US" sz="1200" b="1" u="none" strike="noStrike" dirty="0">
                          <a:effectLst/>
                        </a:rPr>
                        <a:t>Gona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 err="1">
                          <a:effectLst/>
                        </a:rPr>
                        <a:t>Leydig</a:t>
                      </a:r>
                      <a:r>
                        <a:rPr lang="en-US" sz="1200" b="1" u="none" strike="noStrike" dirty="0">
                          <a:effectLst/>
                        </a:rPr>
                        <a:t> Precursor </a:t>
                      </a:r>
                      <a:r>
                        <a:rPr lang="en-US" sz="1200" b="1" u="none" strike="noStrike" dirty="0" smtClean="0">
                          <a:effectLst/>
                        </a:rPr>
                        <a:t>cells: </a:t>
                      </a:r>
                    </a:p>
                    <a:p>
                      <a:pPr algn="l" fontAlgn="b"/>
                      <a:r>
                        <a:rPr lang="en-US" sz="1200" b="1" u="none" strike="noStrike" dirty="0" smtClean="0">
                          <a:effectLst/>
                        </a:rPr>
                        <a:t>Fetal </a:t>
                      </a:r>
                      <a:r>
                        <a:rPr lang="en-US" sz="1200" b="1" u="none" strike="noStrike" dirty="0">
                          <a:effectLst/>
                        </a:rPr>
                        <a:t>Gona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Gonadal Endothelial </a:t>
                      </a:r>
                      <a:r>
                        <a:rPr lang="en-US" sz="1200" b="1" u="none" strike="noStrike" dirty="0" smtClean="0">
                          <a:effectLst/>
                        </a:rPr>
                        <a:t>cells:</a:t>
                      </a:r>
                    </a:p>
                    <a:p>
                      <a:pPr algn="l" fontAlgn="b"/>
                      <a:r>
                        <a:rPr lang="en-US" sz="1200" b="1" u="none" strike="noStrike" dirty="0" smtClean="0">
                          <a:effectLst/>
                        </a:rPr>
                        <a:t>Fetal </a:t>
                      </a:r>
                      <a:r>
                        <a:rPr lang="en-US" sz="1200" b="1" u="none" strike="noStrike" dirty="0">
                          <a:effectLst/>
                        </a:rPr>
                        <a:t>Gona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 err="1">
                          <a:effectLst/>
                        </a:rPr>
                        <a:t>Sertoli</a:t>
                      </a:r>
                      <a:r>
                        <a:rPr lang="en-US" sz="1200" b="1" u="none" strike="noStrike" dirty="0">
                          <a:effectLst/>
                        </a:rPr>
                        <a:t> </a:t>
                      </a:r>
                      <a:r>
                        <a:rPr lang="en-US" sz="1200" b="1" u="none" strike="noStrike" dirty="0" smtClean="0">
                          <a:effectLst/>
                        </a:rPr>
                        <a:t>cells: Fetal </a:t>
                      </a:r>
                      <a:r>
                        <a:rPr lang="en-US" sz="1200" b="1" u="none" strike="noStrike" dirty="0">
                          <a:effectLst/>
                        </a:rPr>
                        <a:t>Gona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Mitotic Fetal Germ </a:t>
                      </a:r>
                      <a:r>
                        <a:rPr lang="en-US" sz="1200" b="1" u="none" strike="noStrike" dirty="0" smtClean="0">
                          <a:effectLst/>
                        </a:rPr>
                        <a:t>cells: Fetal </a:t>
                      </a:r>
                      <a:r>
                        <a:rPr lang="en-US" sz="1200" b="1" u="none" strike="noStrike" dirty="0">
                          <a:effectLst/>
                        </a:rPr>
                        <a:t>Gona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Oogenesis Phase Fetal Germ </a:t>
                      </a:r>
                      <a:r>
                        <a:rPr lang="en-US" sz="1200" b="1" u="none" strike="noStrike" dirty="0" smtClean="0">
                          <a:effectLst/>
                        </a:rPr>
                        <a:t>cells: Fetal </a:t>
                      </a:r>
                      <a:r>
                        <a:rPr lang="en-US" sz="1200" b="1" u="none" strike="noStrike" dirty="0">
                          <a:effectLst/>
                        </a:rPr>
                        <a:t>Gona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Migration Phase Fetal Germ cell</a:t>
                      </a:r>
                      <a:r>
                        <a:rPr lang="en-US" sz="1200" b="1" u="none" strike="noStrike" dirty="0" smtClean="0">
                          <a:effectLst/>
                        </a:rPr>
                        <a:t>: Fetal </a:t>
                      </a:r>
                      <a:r>
                        <a:rPr lang="en-US" sz="1200" b="1" u="none" strike="noStrike" dirty="0">
                          <a:effectLst/>
                        </a:rPr>
                        <a:t>Gona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Endothelial </a:t>
                      </a:r>
                      <a:r>
                        <a:rPr lang="en-US" sz="1200" b="1" u="none" strike="noStrike" dirty="0" smtClean="0">
                          <a:effectLst/>
                        </a:rPr>
                        <a:t>cells: </a:t>
                      </a:r>
                    </a:p>
                    <a:p>
                      <a:pPr algn="l" fontAlgn="b"/>
                      <a:r>
                        <a:rPr lang="en-US" sz="1200" b="1" u="none" strike="noStrike" dirty="0" smtClean="0">
                          <a:effectLst/>
                        </a:rPr>
                        <a:t>Fetal </a:t>
                      </a:r>
                      <a:r>
                        <a:rPr lang="en-US" sz="1200" b="1" u="none" strike="noStrike" dirty="0">
                          <a:effectLst/>
                        </a:rPr>
                        <a:t>Gona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Meiotic Prophase Fetal Germ cell</a:t>
                      </a:r>
                      <a:r>
                        <a:rPr lang="en-US" sz="1200" b="1" u="none" strike="noStrike" dirty="0" smtClean="0">
                          <a:effectLst/>
                        </a:rPr>
                        <a:t>: Fetal </a:t>
                      </a:r>
                      <a:r>
                        <a:rPr lang="en-US" sz="1200" b="1" u="none" strike="noStrike" dirty="0">
                          <a:effectLst/>
                        </a:rPr>
                        <a:t>Gona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Granulosa cell</a:t>
                      </a:r>
                      <a:r>
                        <a:rPr lang="en-US" sz="1200" b="1" u="none" strike="noStrike" dirty="0" smtClean="0">
                          <a:effectLst/>
                        </a:rPr>
                        <a:t>: Fetal </a:t>
                      </a:r>
                      <a:r>
                        <a:rPr lang="en-US" sz="1200" b="1" u="none" strike="noStrike" dirty="0">
                          <a:effectLst/>
                        </a:rPr>
                        <a:t>Gona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 err="1">
                          <a:effectLst/>
                        </a:rPr>
                        <a:t>Leydig</a:t>
                      </a:r>
                      <a:r>
                        <a:rPr lang="en-US" sz="1200" b="1" u="none" strike="noStrike" dirty="0">
                          <a:effectLst/>
                        </a:rPr>
                        <a:t> cell</a:t>
                      </a:r>
                      <a:r>
                        <a:rPr lang="en-US" sz="1200" b="1" u="none" strike="noStrike" dirty="0" smtClean="0">
                          <a:effectLst/>
                        </a:rPr>
                        <a:t>: Fetal </a:t>
                      </a:r>
                      <a:r>
                        <a:rPr lang="en-US" sz="1200" b="1" u="none" strike="noStrike" dirty="0">
                          <a:effectLst/>
                        </a:rPr>
                        <a:t>Gona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Mitotic Arrest Phase Fetal Germ </a:t>
                      </a:r>
                      <a:r>
                        <a:rPr lang="en-US" sz="1200" b="1" u="none" strike="noStrike" dirty="0" smtClean="0">
                          <a:effectLst/>
                        </a:rPr>
                        <a:t>cells: </a:t>
                      </a:r>
                    </a:p>
                    <a:p>
                      <a:pPr algn="l" fontAlgn="b"/>
                      <a:r>
                        <a:rPr lang="en-US" sz="1200" b="1" u="none" strike="noStrike" dirty="0" smtClean="0">
                          <a:effectLst/>
                        </a:rPr>
                        <a:t>Fetal </a:t>
                      </a:r>
                      <a:r>
                        <a:rPr lang="en-US" sz="1200" b="1" u="none" strike="noStrike" dirty="0">
                          <a:effectLst/>
                        </a:rPr>
                        <a:t>Gona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</a:tr>
              <a:tr h="17092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RAB3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EMA5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EMA6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HACD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DAPK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KMT2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WDHD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WDHD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KMT2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EMA5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PGRMC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ERPINE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</a:tr>
              <a:tr h="17092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IFT17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FSTL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TIM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XADR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NV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RBFOX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ZNF72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KLHL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BTG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TFR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ILP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HENMT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</a:tr>
              <a:tr h="17092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OL22A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ERPINE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D10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DH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TMEM5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KCNK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NVL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IDH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NECAB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STA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DNAJB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</a:tr>
              <a:tr h="17092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LC25A1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OLIM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IDH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STA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KLF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OLIM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ZNF48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FAM126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ETD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PIDR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TIM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</a:tr>
              <a:tr h="17092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FAM124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EMP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DAB2IP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LIPH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LC25A1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TMEM6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DR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TBL1XR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</a:tr>
              <a:tr h="17092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EFEMP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PDE5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PLXNA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PRUNE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APN1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DARB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TF7IP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FPT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</a:tr>
              <a:tr h="17092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DNMBP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ITM2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TIMELESS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21ORF9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FAM124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VIP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PHK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DCAF12L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</a:tr>
              <a:tr h="17092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RAB1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PDE4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OSBPL1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EFEMP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RUFY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FOXK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OLIM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</a:tr>
              <a:tr h="17092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NDUFAB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T3GAL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GT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ZNF72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FA2H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TMEM6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IRP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</a:tr>
              <a:tr h="17092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PLXNA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DM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HS6ST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RAB1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FSTL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OSBPL1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A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</a:tr>
              <a:tr h="17092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TOM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LRIG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VIP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NDUFAB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TBL1XR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FAM126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RAD9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</a:tr>
              <a:tr h="17092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OCS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KLF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TOM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KLHL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PGRMC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H3GL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</a:tr>
              <a:tr h="17092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ITM2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PRODH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PSD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BO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</a:tr>
              <a:tr h="170920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ZNF48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CO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POT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</a:tr>
              <a:tr h="170920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ITM2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GK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RAD9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</a:tr>
              <a:tr h="170920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FOLR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LHX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</a:tr>
              <a:tr h="170920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PFKP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NTL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</a:tr>
              <a:tr h="170920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H3GL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</a:tr>
              <a:tr h="170920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LHX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22" marR="7122" marT="7122" marB="0" anchor="b"/>
                </a:tc>
              </a:tr>
            </a:tbl>
          </a:graphicData>
        </a:graphic>
      </p:graphicFrame>
      <p:sp>
        <p:nvSpPr>
          <p:cNvPr id="4" name="Rectangle 3"/>
          <p:cNvSpPr/>
          <p:nvPr/>
        </p:nvSpPr>
        <p:spPr>
          <a:xfrm>
            <a:off x="649351" y="388980"/>
            <a:ext cx="1109566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/>
              <a:t>Human-specific LTR7 and LTR5_Hs associated genes encoding markers of 12 distinct cell populations of fetal </a:t>
            </a:r>
            <a:r>
              <a:rPr lang="en-US" b="1" dirty="0"/>
              <a:t>g</a:t>
            </a:r>
            <a:r>
              <a:rPr lang="en-US" b="1" dirty="0" smtClean="0"/>
              <a:t>onads</a:t>
            </a:r>
            <a:endParaRPr lang="en-US" b="1" dirty="0"/>
          </a:p>
        </p:txBody>
      </p:sp>
      <p:sp>
        <p:nvSpPr>
          <p:cNvPr id="5" name="TextBox 3"/>
          <p:cNvSpPr txBox="1"/>
          <p:nvPr/>
        </p:nvSpPr>
        <p:spPr>
          <a:xfrm>
            <a:off x="0" y="0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161891802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642412" y="961590"/>
            <a:ext cx="5109719" cy="5095840"/>
          </a:xfrm>
          <a:prstGeom prst="rect">
            <a:avLst/>
          </a:prstGeom>
        </p:spPr>
      </p:pic>
      <p:pic>
        <p:nvPicPr>
          <p:cNvPr id="3" name="Picture 2" descr="https://appyters.maayanlab.cloud/Enrichment_Analysis_Visualizer/475d65c5f4cf1fbecc41dfc5a220b19f21f85500/Enrichr_results_ba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45192" y="2061713"/>
            <a:ext cx="5762446" cy="42700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Rectangle 3"/>
          <p:cNvSpPr/>
          <p:nvPr/>
        </p:nvSpPr>
        <p:spPr>
          <a:xfrm>
            <a:off x="698910" y="216453"/>
            <a:ext cx="10861628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b="1" dirty="0" smtClean="0"/>
              <a:t>Human-specific LTR7 and LTR5_Hs associated genes encoding markers of distinct cell populations of fetal gonads</a:t>
            </a:r>
          </a:p>
          <a:p>
            <a:pPr algn="ctr"/>
            <a:r>
              <a:rPr lang="en-US" b="1" dirty="0" smtClean="0"/>
              <a:t>Top 10 significantly enriched records</a:t>
            </a:r>
            <a:endParaRPr lang="en-US" b="1" dirty="0"/>
          </a:p>
        </p:txBody>
      </p:sp>
      <p:sp>
        <p:nvSpPr>
          <p:cNvPr id="5" name="TextBox 3"/>
          <p:cNvSpPr txBox="1"/>
          <p:nvPr/>
        </p:nvSpPr>
        <p:spPr>
          <a:xfrm>
            <a:off x="0" y="0"/>
            <a:ext cx="3417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18947150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</TotalTime>
  <Words>342</Words>
  <Application>Microsoft Office PowerPoint</Application>
  <PresentationFormat>Widescreen</PresentationFormat>
  <Paragraphs>163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Supplementary Figure S2. GSEA of 247 genes linked by GREAT with 351 human-specific LTR7 and LTR5_Hs using the Enrichr bioinformatics platform (A – F). Related to Figure 5. Inference of putative phenotypic impacts of human-specific LTR7 &amp; LTR5_Hs loci based on GREAT algorithm-guided functional annotations of proximity placement-linked genes.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 lncHUB lncRNA co-expression</dc:title>
  <dc:creator>Guennadi Glinskii</dc:creator>
  <cp:lastModifiedBy>Guennadi Glinskii</cp:lastModifiedBy>
  <cp:revision>14</cp:revision>
  <dcterms:created xsi:type="dcterms:W3CDTF">2022-03-20T22:47:11Z</dcterms:created>
  <dcterms:modified xsi:type="dcterms:W3CDTF">2022-04-21T05:39:27Z</dcterms:modified>
</cp:coreProperties>
</file>